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669088" cy="9926638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8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>
        <p:scale>
          <a:sx n="120" d="100"/>
          <a:sy n="120" d="100"/>
        </p:scale>
        <p:origin x="84" y="-3660"/>
      </p:cViewPr>
      <p:guideLst>
        <p:guide orient="horz" pos="228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38052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787489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109791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60930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48920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93108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48648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87831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5251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01375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a-DK" smtClean="0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8651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E9DBE-E314-4E84-945F-A59CB3D5A2CE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229198-92E2-490D-BF55-FC31D031602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54178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Tekstfelt 79"/>
          <p:cNvSpPr txBox="1"/>
          <p:nvPr/>
        </p:nvSpPr>
        <p:spPr>
          <a:xfrm>
            <a:off x="298771" y="15698038"/>
            <a:ext cx="2601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a-DK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a-DK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a-DK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a-DK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da-DK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kstfelt 57"/>
          <p:cNvSpPr txBox="1"/>
          <p:nvPr/>
        </p:nvSpPr>
        <p:spPr>
          <a:xfrm rot="16200000">
            <a:off x="1457253" y="965282"/>
            <a:ext cx="16161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14 pH7.5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kstfelt 58"/>
          <p:cNvSpPr txBox="1"/>
          <p:nvPr/>
        </p:nvSpPr>
        <p:spPr>
          <a:xfrm rot="16200000">
            <a:off x="3313959" y="965282"/>
            <a:ext cx="16161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14 pH6.3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kstfelt 59"/>
          <p:cNvSpPr txBox="1"/>
          <p:nvPr/>
        </p:nvSpPr>
        <p:spPr>
          <a:xfrm rot="16200000">
            <a:off x="1828968" y="965282"/>
            <a:ext cx="16161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15 pH7.5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kstfelt 60"/>
          <p:cNvSpPr txBox="1"/>
          <p:nvPr/>
        </p:nvSpPr>
        <p:spPr>
          <a:xfrm rot="16200000">
            <a:off x="460168" y="1171268"/>
            <a:ext cx="1204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SiHa pH7.5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kstfelt 61"/>
          <p:cNvSpPr txBox="1"/>
          <p:nvPr/>
        </p:nvSpPr>
        <p:spPr>
          <a:xfrm rot="16200000">
            <a:off x="2289674" y="1171268"/>
            <a:ext cx="1204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SiHa pH6.3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kstfelt 62"/>
          <p:cNvSpPr txBox="1"/>
          <p:nvPr/>
        </p:nvSpPr>
        <p:spPr>
          <a:xfrm rot="16200000">
            <a:off x="587917" y="1118369"/>
            <a:ext cx="1309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SiHa pH7.5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kstfelt 63"/>
          <p:cNvSpPr txBox="1"/>
          <p:nvPr/>
        </p:nvSpPr>
        <p:spPr>
          <a:xfrm rot="16200000">
            <a:off x="2412528" y="1118369"/>
            <a:ext cx="1309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SiHa pH6.3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kstfelt 64"/>
          <p:cNvSpPr txBox="1"/>
          <p:nvPr/>
        </p:nvSpPr>
        <p:spPr>
          <a:xfrm rot="16200000">
            <a:off x="719834" y="1091118"/>
            <a:ext cx="13644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FaDu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DD</a:t>
            </a:r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 pH7.5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kstfelt 65"/>
          <p:cNvSpPr txBox="1"/>
          <p:nvPr/>
        </p:nvSpPr>
        <p:spPr>
          <a:xfrm rot="16200000">
            <a:off x="2561030" y="1091118"/>
            <a:ext cx="13644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FaDu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DD</a:t>
            </a:r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 pH6.3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kstfelt 66"/>
          <p:cNvSpPr txBox="1"/>
          <p:nvPr/>
        </p:nvSpPr>
        <p:spPr>
          <a:xfrm rot="16200000">
            <a:off x="847583" y="1038219"/>
            <a:ext cx="14702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FaDu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DD</a:t>
            </a:r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 pH7.5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kstfelt 67"/>
          <p:cNvSpPr txBox="1"/>
          <p:nvPr/>
        </p:nvSpPr>
        <p:spPr>
          <a:xfrm rot="16200000">
            <a:off x="2683884" y="1038219"/>
            <a:ext cx="14702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FaDu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DD</a:t>
            </a:r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 pH6.3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kstfelt 70"/>
          <p:cNvSpPr txBox="1"/>
          <p:nvPr/>
        </p:nvSpPr>
        <p:spPr>
          <a:xfrm rot="16200000">
            <a:off x="1014323" y="1053447"/>
            <a:ext cx="1439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5 pH7.5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kstfelt 71"/>
          <p:cNvSpPr txBox="1"/>
          <p:nvPr/>
        </p:nvSpPr>
        <p:spPr>
          <a:xfrm rot="16200000">
            <a:off x="2874865" y="1053447"/>
            <a:ext cx="1439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5 pH6.3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kstfelt 72"/>
          <p:cNvSpPr txBox="1"/>
          <p:nvPr/>
        </p:nvSpPr>
        <p:spPr>
          <a:xfrm rot="16200000">
            <a:off x="1142072" y="1000548"/>
            <a:ext cx="15456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5 pH7.5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kstfelt 73"/>
          <p:cNvSpPr txBox="1"/>
          <p:nvPr/>
        </p:nvSpPr>
        <p:spPr>
          <a:xfrm rot="16200000">
            <a:off x="2997719" y="1000548"/>
            <a:ext cx="15456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5 pH6.3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kstfelt 74"/>
          <p:cNvSpPr txBox="1"/>
          <p:nvPr/>
        </p:nvSpPr>
        <p:spPr>
          <a:xfrm rot="16200000">
            <a:off x="1329504" y="1018181"/>
            <a:ext cx="15103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14 pH7.5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kstfelt 75"/>
          <p:cNvSpPr txBox="1"/>
          <p:nvPr/>
        </p:nvSpPr>
        <p:spPr>
          <a:xfrm rot="16200000">
            <a:off x="3191105" y="1018181"/>
            <a:ext cx="15103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14 pH6.3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kstfelt 76"/>
          <p:cNvSpPr txBox="1"/>
          <p:nvPr/>
        </p:nvSpPr>
        <p:spPr>
          <a:xfrm rot="16200000">
            <a:off x="1701219" y="1018181"/>
            <a:ext cx="15103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15 pH7.5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kstfelt 77"/>
          <p:cNvSpPr txBox="1"/>
          <p:nvPr/>
        </p:nvSpPr>
        <p:spPr>
          <a:xfrm rot="16200000">
            <a:off x="3542611" y="1018181"/>
            <a:ext cx="15103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15 pH6.3 5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kstfelt 78"/>
          <p:cNvSpPr txBox="1"/>
          <p:nvPr/>
        </p:nvSpPr>
        <p:spPr>
          <a:xfrm rot="16200000">
            <a:off x="3665468" y="965282"/>
            <a:ext cx="16161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latin typeface="Arial" panose="020B0604020202020204" pitchFamily="34" charset="0"/>
                <a:cs typeface="Arial" panose="020B0604020202020204" pitchFamily="34" charset="0"/>
              </a:rPr>
              <a:t>UTSCC15 pH6.3 0.1%O</a:t>
            </a:r>
            <a:r>
              <a:rPr lang="da-DK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Gruppe 38"/>
          <p:cNvGrpSpPr/>
          <p:nvPr/>
        </p:nvGrpSpPr>
        <p:grpSpPr>
          <a:xfrm>
            <a:off x="4692922" y="849658"/>
            <a:ext cx="634215" cy="930642"/>
            <a:chOff x="3712872" y="346288"/>
            <a:chExt cx="634215" cy="930642"/>
          </a:xfrm>
        </p:grpSpPr>
        <p:pic>
          <p:nvPicPr>
            <p:cNvPr id="40" name="Billede 3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4017"/>
            <a:stretch/>
          </p:blipFill>
          <p:spPr>
            <a:xfrm rot="5400000">
              <a:off x="3359545" y="738897"/>
              <a:ext cx="847725" cy="141071"/>
            </a:xfrm>
            <a:prstGeom prst="rect">
              <a:avLst/>
            </a:prstGeom>
          </p:spPr>
        </p:pic>
        <p:sp>
          <p:nvSpPr>
            <p:cNvPr id="54" name="Tekstfelt 53"/>
            <p:cNvSpPr txBox="1"/>
            <p:nvPr/>
          </p:nvSpPr>
          <p:spPr>
            <a:xfrm>
              <a:off x="3774494" y="346288"/>
              <a:ext cx="5725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≤0.125</a:t>
              </a:r>
              <a:endParaRPr lang="da-DK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kstfelt 55"/>
            <p:cNvSpPr txBox="1"/>
            <p:nvPr/>
          </p:nvSpPr>
          <p:spPr>
            <a:xfrm>
              <a:off x="3774494" y="460358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5</a:t>
              </a:r>
              <a:endParaRPr lang="da-DK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kstfelt 56"/>
            <p:cNvSpPr txBox="1"/>
            <p:nvPr/>
          </p:nvSpPr>
          <p:spPr>
            <a:xfrm>
              <a:off x="3774494" y="574428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da-DK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kstfelt 68"/>
            <p:cNvSpPr txBox="1"/>
            <p:nvPr/>
          </p:nvSpPr>
          <p:spPr>
            <a:xfrm>
              <a:off x="3774494" y="68849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da-DK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kstfelt 69"/>
            <p:cNvSpPr txBox="1"/>
            <p:nvPr/>
          </p:nvSpPr>
          <p:spPr>
            <a:xfrm>
              <a:off x="3774494" y="80256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da-DK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kstfelt 81"/>
            <p:cNvSpPr txBox="1"/>
            <p:nvPr/>
          </p:nvSpPr>
          <p:spPr>
            <a:xfrm>
              <a:off x="3774494" y="91663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da-DK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kstfelt 82"/>
            <p:cNvSpPr txBox="1"/>
            <p:nvPr/>
          </p:nvSpPr>
          <p:spPr>
            <a:xfrm>
              <a:off x="3774494" y="103070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≥8</a:t>
              </a:r>
              <a:endParaRPr lang="da-DK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" name="Billed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486" r="25789"/>
          <a:stretch/>
        </p:blipFill>
        <p:spPr>
          <a:xfrm>
            <a:off x="957739" y="1807124"/>
            <a:ext cx="1806726" cy="1807200"/>
          </a:xfrm>
          <a:prstGeom prst="rect">
            <a:avLst/>
          </a:prstGeom>
        </p:spPr>
      </p:pic>
      <p:pic>
        <p:nvPicPr>
          <p:cNvPr id="3" name="Billede 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833" r="25842"/>
          <a:stretch/>
        </p:blipFill>
        <p:spPr>
          <a:xfrm>
            <a:off x="2781920" y="1825835"/>
            <a:ext cx="1799087" cy="17884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85491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</TotalTime>
  <Words>72</Words>
  <Application>Microsoft Office PowerPoint</Application>
  <PresentationFormat>Brugerdefineret</PresentationFormat>
  <Paragraphs>28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Brita Singers Sørensen</dc:creator>
  <cp:lastModifiedBy>Brita Singers Sørensen</cp:lastModifiedBy>
  <cp:revision>14</cp:revision>
  <cp:lastPrinted>2014-08-28T12:15:29Z</cp:lastPrinted>
  <dcterms:created xsi:type="dcterms:W3CDTF">2014-08-28T11:42:19Z</dcterms:created>
  <dcterms:modified xsi:type="dcterms:W3CDTF">2015-07-02T09:52:24Z</dcterms:modified>
</cp:coreProperties>
</file>